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C854E2-45F3-450D-A173-38D2A7F5168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CC099A-1014-49F8-B527-687F82ED85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75C3F9-0201-43F1-9147-A71E86A83F0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5D7D27-2844-411F-9A50-B4BDC0D9E9E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612BA7-DBB4-4DEB-9D57-46D33170FA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2C342A-FBA9-4807-8C13-F335B38D8A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681F32-9626-4AF6-95F5-BB131C9AF2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A60F4B-594D-4C73-A279-559352355B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7CE284-5D3D-4340-B89C-501A2FE2C8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893B6E-A7B1-4679-A51A-2665A87505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D5F304-00EE-4A74-A985-4E10EAE5B3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6C96A6-F9E3-427F-84A2-AB7B1CA60E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FAADB7-34A9-4CEB-93C3-CB4C0AE5958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447920" y="609480"/>
          <a:ext cx="7238880" cy="3292560"/>
        </p:xfrm>
        <a:graphic>
          <a:graphicData uri="http://schemas.openxmlformats.org/drawingml/2006/table">
            <a:tbl>
              <a:tblPr/>
              <a:tblGrid>
                <a:gridCol w="904680"/>
                <a:gridCol w="2871720"/>
                <a:gridCol w="3462480"/>
              </a:tblGrid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rward primer (5' -  3'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verse primer (5' -  3'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57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g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g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G GCA GCG ACC AAA GCA AGC 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CGTTGCTGGACCTCA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GA GGT CGG CGG CGT CAA GGT CGA GG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CTCCATCGCTCGGATC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s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GTGGTCCGTTTGGAAC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GGTCAAGCTCGACGTTG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3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GGGTTATGGCATCGCTT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GCCGTGCGAGATCG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43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v2745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CT CGG GTA TCT GTC GGA GAT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C TGC AGA GCC GTA CAA ATC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57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v3160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TGGACCACCTGCATGCT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CATCTCCGCGACTAGCT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57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v3161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GGGTTCCCTTCACCGT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GGAATAAAGCCGAACCA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v3614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ACAGGTCGATGCAGATGA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GCCCACGGTCTTACG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v3615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GTACTTGACTGCCCACAATG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GACACCGGCCGTAT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v3616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GCACCCTCGGAGAAGTG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CTCTTTCAGGCCGTTG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2" name="Rectangle 1"/>
          <p:cNvSpPr/>
          <p:nvPr/>
        </p:nvSpPr>
        <p:spPr>
          <a:xfrm>
            <a:off x="3642840" y="228600"/>
            <a:ext cx="2709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Table S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. Primers used for the qRT-PC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06T19:46:06Z</dcterms:created>
  <dc:creator>ndutta</dc:creator>
  <dc:description/>
  <dc:language>en-US</dc:language>
  <cp:lastModifiedBy>ndutta</cp:lastModifiedBy>
  <dcterms:modified xsi:type="dcterms:W3CDTF">2010-03-16T22:32:54Z</dcterms:modified>
  <cp:revision>53</cp:revision>
  <dc:subject/>
  <dc:title>Slide 1</dc:title>
</cp:coreProperties>
</file>